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  <p:sldId id="262" r:id="rId4"/>
    <p:sldId id="259" r:id="rId5"/>
    <p:sldId id="263" r:id="rId6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1666" y="-220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C5B470-9EFF-CAE9-C267-DED08C25BE6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407C5AD-FB17-DCC0-69C9-7D083672AA3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87C0A3-7573-0151-F673-F1718ED3BC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156D5-3622-479C-B749-FD62081353EF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93A463-A698-1AD5-2166-5E8710CA81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C2016E-61EA-30B5-CA56-880739719D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12FA7-7257-49E8-AABB-13FBFFC908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8622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513331-4F48-FDFD-CC76-6DEFA89F12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AF3DE15-FBDE-80E4-66AF-0FEF1535BD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0B2AFF-41F5-46A8-196A-413EA734A5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156D5-3622-479C-B749-FD62081353EF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D529C8-D82B-5940-E2CD-413E112C9A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C8A781-C35C-4908-8C50-15A93ED919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12FA7-7257-49E8-AABB-13FBFFC908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1619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72B3621-9C0E-DC18-1390-C4B15603BA5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67CABDA-DAD6-2D2D-4477-B617792D81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EE6968-3E84-1187-1B43-41D983DF61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156D5-3622-479C-B749-FD62081353EF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57855C-31E9-D6A8-5FA1-EB0367FDB9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C1E29F-2A19-A555-FAEA-6196DA80EF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12FA7-7257-49E8-AABB-13FBFFC908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1225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C12F98-961C-5473-696A-AFAEE677CE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1EDC56-06E1-45ED-3D87-98A69D80873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E20B97-6383-FD21-0820-27FA1E6A9A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156D5-3622-479C-B749-FD62081353EF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F5AF17-3986-EAEF-B107-D8C1F232A5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0C0CF3-3A8F-392C-2CD3-5ADC050F07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12FA7-7257-49E8-AABB-13FBFFC908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0080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14F657-B3E9-69E8-63AF-242E50EF0C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D4BB14E-BE32-7482-871E-6A2105289F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82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82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7B95F3-3402-AC25-077C-8A4FDF92C9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156D5-3622-479C-B749-FD62081353EF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F0948A-C501-3EFD-E29E-279DEA1AC1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D3C5AE-E073-1A8B-CAF4-DE9D748766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12FA7-7257-49E8-AABB-13FBFFC908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9602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6ED719-7443-4341-D8FD-0FEAE86865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EC1AE0-E226-2C2C-80BC-ED51CD163B4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16197CF-28C1-0FEE-070A-348BDA20D0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8007EE-5B8D-2F20-A76A-B922063472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156D5-3622-479C-B749-FD62081353EF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3BA09D-6F75-4A67-012E-8C6BBE149D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0DAD24-0F80-3410-93D4-3F2C3EBC34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12FA7-7257-49E8-AABB-13FBFFC908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69004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DD104A-C1D9-834B-731B-63D49532F3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2296C9-5DB7-3D31-9CAB-1DF46EC84D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667CD82-D396-C23B-AB2D-9AA4169BB7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12F71AE-AE2D-CE32-838D-F265E6ECA88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9DD124D-68B4-F48E-2B0D-2450A91AF91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0A456FB-B1B3-A43A-6248-77A78A4DDE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156D5-3622-479C-B749-FD62081353EF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2EC92ED-7ABA-DA2F-6AB7-0C619972C2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9C6A63E-8E2B-D594-3516-02645C611D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12FA7-7257-49E8-AABB-13FBFFC908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1679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247FF8-9A0B-07C6-68F5-C25361CDCC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9598E02-B20E-15CA-05CD-AC6FE8F701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156D5-3622-479C-B749-FD62081353EF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D1FD5C3-999C-0608-08CA-4E1F4179E8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E9576DA-D38C-29DA-41F0-35FBBA4A28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12FA7-7257-49E8-AABB-13FBFFC908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5851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43E8AE2-FE9F-8E2B-3C05-DA23140ED5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156D5-3622-479C-B749-FD62081353EF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0E29BA6-1085-AB07-05B5-5C30E449CF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8B675D0-54C7-85F9-6452-D7E24574D1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12FA7-7257-49E8-AABB-13FBFFC908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9240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983CBF-FDA4-2B34-7CB7-F9C513A473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CF4F89-5DC4-32AB-08CA-2B3AEEABB81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84892B1-C5F3-AF69-8437-FAE3541BB1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69E087-3EC8-CE81-20B1-29AD4E6516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156D5-3622-479C-B749-FD62081353EF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8F9F4EA-DA1B-3A77-B8CE-AD0E9286F1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500A51-3422-9BC7-967B-0919404939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12FA7-7257-49E8-AABB-13FBFFC908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4177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BE0977-C7EA-8485-59C9-5682CBF6E3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1D1490D-9F2E-F1DA-1BC8-E64A783863E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D371270-8AA8-441D-01A4-59598B1723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B749E98-0BE4-9D1B-D175-E0C9E3FE45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156D5-3622-479C-B749-FD62081353EF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88F070-95E6-5D3B-019A-1BB7C7DD5D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AF36EA1-4A22-1FB0-02A1-B18E6DE9DB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12FA7-7257-49E8-AABB-13FBFFC908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69145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01FD7E3-8F35-4CD9-E8D3-FEF4931B7C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337772-28B9-C4B2-5448-CAFD45A8AA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7D7505-E728-EF98-B07C-C38DF9976AB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C0156D5-3622-479C-B749-FD62081353EF}" type="datetimeFigureOut">
              <a:rPr lang="en-US" smtClean="0"/>
              <a:t>2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8BC4FC-EED2-D0EF-9EBF-D14F297D04D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C1078B-9FB4-B7F7-4FCA-65D7B893B7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BA12FA7-7257-49E8-AABB-13FBFFC908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0709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sv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svg"/><Relationship Id="rId5" Type="http://schemas.openxmlformats.org/officeDocument/2006/relationships/image" Target="../media/image2.png"/><Relationship Id="rId4" Type="http://schemas.openxmlformats.org/officeDocument/2006/relationships/image" Target="../media/image6.sv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svg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svg"/><Relationship Id="rId5" Type="http://schemas.openxmlformats.org/officeDocument/2006/relationships/image" Target="../media/image2.png"/><Relationship Id="rId4" Type="http://schemas.openxmlformats.org/officeDocument/2006/relationships/image" Target="../media/image9.sv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sv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svg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FC9B974-3E6E-97BE-9304-59DB67CE6A5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9791A78-EF70-409C-8E4E-2A650D3007F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3923" y="904279"/>
            <a:ext cx="5628002" cy="1865426"/>
          </a:xfrm>
          <a:prstGeom prst="rect">
            <a:avLst/>
          </a:prstGeom>
        </p:spPr>
      </p:pic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A778ED24-5703-7D38-E5CB-44704C7F8E4B}"/>
              </a:ext>
            </a:extLst>
          </p:cNvPr>
          <p:cNvCxnSpPr>
            <a:cxnSpLocks/>
          </p:cNvCxnSpPr>
          <p:nvPr/>
        </p:nvCxnSpPr>
        <p:spPr>
          <a:xfrm>
            <a:off x="1600553" y="904279"/>
            <a:ext cx="0" cy="1629786"/>
          </a:xfrm>
          <a:prstGeom prst="line">
            <a:avLst/>
          </a:prstGeom>
          <a:ln w="12700">
            <a:prstDash val="sysDash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F26A6E74-0945-F930-BB90-5BD0016815BD}"/>
              </a:ext>
            </a:extLst>
          </p:cNvPr>
          <p:cNvCxnSpPr>
            <a:cxnSpLocks/>
          </p:cNvCxnSpPr>
          <p:nvPr/>
        </p:nvCxnSpPr>
        <p:spPr>
          <a:xfrm flipH="1">
            <a:off x="665599" y="2811468"/>
            <a:ext cx="934954" cy="53253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6DEB7251-C50B-8E84-1381-FB0A3365A457}"/>
              </a:ext>
            </a:extLst>
          </p:cNvPr>
          <p:cNvCxnSpPr>
            <a:cxnSpLocks/>
          </p:cNvCxnSpPr>
          <p:nvPr/>
        </p:nvCxnSpPr>
        <p:spPr>
          <a:xfrm>
            <a:off x="1600553" y="2804653"/>
            <a:ext cx="4583029" cy="53675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F48128C3-9FE9-831C-420D-311CEB86ABA5}"/>
              </a:ext>
            </a:extLst>
          </p:cNvPr>
          <p:cNvCxnSpPr/>
          <p:nvPr/>
        </p:nvCxnSpPr>
        <p:spPr>
          <a:xfrm>
            <a:off x="1600553" y="2555917"/>
            <a:ext cx="0" cy="233699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D950198A-7304-011B-EC95-53770F1E706A}"/>
              </a:ext>
            </a:extLst>
          </p:cNvPr>
          <p:cNvSpPr txBox="1"/>
          <p:nvPr/>
        </p:nvSpPr>
        <p:spPr>
          <a:xfrm>
            <a:off x="719973" y="6751807"/>
            <a:ext cx="5545851" cy="12772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Manhattan plot and linkage disequilibrium (LD) plot for head smut disease susceptibility highlighting SNP locus S2_13166258.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Manhattan plot showing significant SNPs associated with head smut disease across the genome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reen</a:t>
            </a:r>
            <a:r>
              <a:rPr lang="en-US" sz="1100" b="0" i="0" dirty="0">
                <a:solidFill>
                  <a:srgbClr val="1C1D1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orizontal dashed </a:t>
            </a:r>
            <a:r>
              <a:rPr lang="en-US" sz="1100" b="0" i="0" dirty="0">
                <a:solidFill>
                  <a:srgbClr val="1C1D1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ine indicates the genome-wide significance threshold </a:t>
            </a:r>
            <a:r>
              <a:rPr lang="en-US" sz="11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100" i="1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1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value &lt;</a:t>
            </a:r>
            <a:r>
              <a:rPr lang="en-US" sz="1100" b="0" i="0" dirty="0">
                <a:solidFill>
                  <a:srgbClr val="1C1D1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E-5, 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−log</a:t>
            </a:r>
            <a:r>
              <a:rPr lang="en-US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5</a:t>
            </a:r>
            <a:r>
              <a:rPr lang="en-US" sz="1100" b="0" i="0" dirty="0">
                <a:solidFill>
                  <a:srgbClr val="1C1D1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. Black vertical dashed line shows the positions of quantitative trait nucleotide (QTN) at chromosome 2. (B) LD plot constructed using </a:t>
            </a:r>
            <a:r>
              <a:rPr lang="en-US" sz="1100" b="0" i="0" dirty="0" err="1">
                <a:solidFill>
                  <a:srgbClr val="1C1D1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aploview</a:t>
            </a:r>
            <a:r>
              <a:rPr lang="en-US" sz="1100" b="0" i="0" dirty="0">
                <a:solidFill>
                  <a:srgbClr val="1C1D1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4.2 for 100kb genomic region surrounding the significant SNPs. Color </a:t>
            </a:r>
            <a:r>
              <a:rPr lang="en-US" sz="11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cale indicates LD strength expressed as </a:t>
            </a:r>
            <a:r>
              <a:rPr lang="en-US" sz="1100" i="1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100" baseline="300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1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D6D1A69-F3F7-624D-B61C-C95E097EE8B0}"/>
              </a:ext>
            </a:extLst>
          </p:cNvPr>
          <p:cNvSpPr txBox="1"/>
          <p:nvPr/>
        </p:nvSpPr>
        <p:spPr>
          <a:xfrm rot="16200000">
            <a:off x="-49440" y="1613677"/>
            <a:ext cx="82465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−log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591A2AC-C38B-8259-27CA-F351A891C04E}"/>
              </a:ext>
            </a:extLst>
          </p:cNvPr>
          <p:cNvSpPr txBox="1"/>
          <p:nvPr/>
        </p:nvSpPr>
        <p:spPr>
          <a:xfrm>
            <a:off x="2638778" y="2695627"/>
            <a:ext cx="10711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hromosome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B7AD81A-CB78-1DDB-2496-609930FDBDA8}"/>
              </a:ext>
            </a:extLst>
          </p:cNvPr>
          <p:cNvSpPr txBox="1"/>
          <p:nvPr/>
        </p:nvSpPr>
        <p:spPr>
          <a:xfrm>
            <a:off x="200500" y="499999"/>
            <a:ext cx="455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A)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B7976002-5068-81AD-ED13-F623E2175C84}"/>
              </a:ext>
            </a:extLst>
          </p:cNvPr>
          <p:cNvSpPr txBox="1"/>
          <p:nvPr/>
        </p:nvSpPr>
        <p:spPr>
          <a:xfrm>
            <a:off x="264399" y="2972078"/>
            <a:ext cx="455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B)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B761BBB4-8878-ADDF-2265-E2BD855FC872}"/>
              </a:ext>
            </a:extLst>
          </p:cNvPr>
          <p:cNvGrpSpPr/>
          <p:nvPr/>
        </p:nvGrpSpPr>
        <p:grpSpPr>
          <a:xfrm>
            <a:off x="7465529" y="4761020"/>
            <a:ext cx="298480" cy="1228931"/>
            <a:chOff x="5530049" y="5020100"/>
            <a:chExt cx="298480" cy="1228931"/>
          </a:xfrm>
        </p:grpSpPr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DF6EBB0F-FCE5-A99A-96F7-9463743E2839}"/>
                </a:ext>
              </a:extLst>
            </p:cNvPr>
            <p:cNvSpPr txBox="1"/>
            <p:nvPr/>
          </p:nvSpPr>
          <p:spPr>
            <a:xfrm>
              <a:off x="5530049" y="5020100"/>
              <a:ext cx="2984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1200" baseline="30000" dirty="0"/>
                <a:t>2</a:t>
              </a:r>
            </a:p>
          </p:txBody>
        </p:sp>
        <p:pic>
          <p:nvPicPr>
            <p:cNvPr id="48" name="Graphic 47">
              <a:extLst>
                <a:ext uri="{FF2B5EF4-FFF2-40B4-BE49-F238E27FC236}">
                  <a16:creationId xmlns:a16="http://schemas.microsoft.com/office/drawing/2014/main" id="{B7AFBC75-2494-3C52-F273-70B5A7BBD81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5610998" y="5243191"/>
              <a:ext cx="193716" cy="1005840"/>
            </a:xfrm>
            <a:prstGeom prst="rect">
              <a:avLst/>
            </a:prstGeom>
          </p:spPr>
        </p:pic>
      </p:grpSp>
      <p:pic>
        <p:nvPicPr>
          <p:cNvPr id="7" name="Picture 6">
            <a:extLst>
              <a:ext uri="{FF2B5EF4-FFF2-40B4-BE49-F238E27FC236}">
                <a16:creationId xmlns:a16="http://schemas.microsoft.com/office/drawing/2014/main" id="{2BB82651-343E-8090-34B9-EC888C9914A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6074" y="3363262"/>
            <a:ext cx="5545851" cy="30725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42955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F6EED52-6A2F-8F35-248E-82A9A771037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9E1CF1D-7EEB-4385-209D-AD7BA2F27AE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3923" y="904279"/>
            <a:ext cx="5628002" cy="1865426"/>
          </a:xfrm>
          <a:prstGeom prst="rect">
            <a:avLst/>
          </a:prstGeom>
        </p:spPr>
      </p:pic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6B265B43-A561-DB22-CA60-74E674962DCA}"/>
              </a:ext>
            </a:extLst>
          </p:cNvPr>
          <p:cNvCxnSpPr>
            <a:cxnSpLocks/>
          </p:cNvCxnSpPr>
          <p:nvPr/>
        </p:nvCxnSpPr>
        <p:spPr>
          <a:xfrm>
            <a:off x="2638778" y="904279"/>
            <a:ext cx="0" cy="1629786"/>
          </a:xfrm>
          <a:prstGeom prst="line">
            <a:avLst/>
          </a:prstGeom>
          <a:ln w="12700">
            <a:prstDash val="sysDash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8235CB8E-974C-7038-AF5D-4DE9ABE00357}"/>
              </a:ext>
            </a:extLst>
          </p:cNvPr>
          <p:cNvCxnSpPr>
            <a:cxnSpLocks/>
          </p:cNvCxnSpPr>
          <p:nvPr/>
        </p:nvCxnSpPr>
        <p:spPr>
          <a:xfrm>
            <a:off x="2714978" y="904279"/>
            <a:ext cx="0" cy="1629786"/>
          </a:xfrm>
          <a:prstGeom prst="line">
            <a:avLst/>
          </a:prstGeom>
          <a:ln w="12700">
            <a:prstDash val="sysDash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7C04DA12-294B-EB22-0C65-77DE84422CB7}"/>
              </a:ext>
            </a:extLst>
          </p:cNvPr>
          <p:cNvCxnSpPr>
            <a:cxnSpLocks/>
          </p:cNvCxnSpPr>
          <p:nvPr/>
        </p:nvCxnSpPr>
        <p:spPr>
          <a:xfrm flipH="1">
            <a:off x="665599" y="2851523"/>
            <a:ext cx="1959940" cy="49247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FC048E61-1224-581B-39B1-E97A00C0F1F6}"/>
              </a:ext>
            </a:extLst>
          </p:cNvPr>
          <p:cNvCxnSpPr>
            <a:cxnSpLocks/>
          </p:cNvCxnSpPr>
          <p:nvPr/>
        </p:nvCxnSpPr>
        <p:spPr>
          <a:xfrm>
            <a:off x="2638778" y="2851523"/>
            <a:ext cx="3544804" cy="48988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9B1868F9-E4F9-D8B2-05A7-4A089F8B1CD3}"/>
              </a:ext>
            </a:extLst>
          </p:cNvPr>
          <p:cNvCxnSpPr/>
          <p:nvPr/>
        </p:nvCxnSpPr>
        <p:spPr>
          <a:xfrm>
            <a:off x="2639131" y="2547452"/>
            <a:ext cx="0" cy="233699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4F359565-B3BE-33FD-F22F-59F212F8D4B6}"/>
              </a:ext>
            </a:extLst>
          </p:cNvPr>
          <p:cNvSpPr txBox="1"/>
          <p:nvPr/>
        </p:nvSpPr>
        <p:spPr>
          <a:xfrm>
            <a:off x="719973" y="6751807"/>
            <a:ext cx="5545851" cy="12772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Manhattan plot and linkage disequilibrium (LD) plot for head smut disease susceptibility highlighting SNP loci S4_9632221  and S4_1010468.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Manhattan plot showing significant SNPs associated with head smut disease across the genome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reen</a:t>
            </a:r>
            <a:r>
              <a:rPr lang="en-US" sz="1100" b="0" i="0" dirty="0">
                <a:solidFill>
                  <a:srgbClr val="1C1D1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orizontal dashed </a:t>
            </a:r>
            <a:r>
              <a:rPr lang="en-US" sz="1100" b="0" i="0" dirty="0">
                <a:solidFill>
                  <a:srgbClr val="1C1D1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ine indicates the genome-wide significance threshold </a:t>
            </a:r>
            <a:r>
              <a:rPr lang="en-US" sz="11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100" i="1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1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value &lt;</a:t>
            </a:r>
            <a:r>
              <a:rPr lang="en-US" sz="1100" b="0" i="0" dirty="0">
                <a:solidFill>
                  <a:srgbClr val="1C1D1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E-5, 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−log</a:t>
            </a:r>
            <a:r>
              <a:rPr lang="en-US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5</a:t>
            </a:r>
            <a:r>
              <a:rPr lang="en-US" sz="1100" b="0" i="0" dirty="0">
                <a:solidFill>
                  <a:srgbClr val="1C1D1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. Black vertical dashed line shows the positions of quantitative trait nucleotide (QTN) at chromosome 4. (B) LD plot constructed using </a:t>
            </a:r>
            <a:r>
              <a:rPr lang="en-US" sz="1100" b="0" i="0" dirty="0" err="1">
                <a:solidFill>
                  <a:srgbClr val="1C1D1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aploview</a:t>
            </a:r>
            <a:r>
              <a:rPr lang="en-US" sz="1100" b="0" i="0" dirty="0">
                <a:solidFill>
                  <a:srgbClr val="1C1D1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4.2 for 100kb genomic region surrounding the significant SNPs. Color </a:t>
            </a:r>
            <a:r>
              <a:rPr lang="en-US" sz="11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cale indicates LD strength expressed as </a:t>
            </a:r>
            <a:r>
              <a:rPr lang="en-US" sz="1100" i="1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100" baseline="300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1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382CF08-C499-9957-F51D-463F5A3AC011}"/>
              </a:ext>
            </a:extLst>
          </p:cNvPr>
          <p:cNvSpPr txBox="1"/>
          <p:nvPr/>
        </p:nvSpPr>
        <p:spPr>
          <a:xfrm rot="16200000">
            <a:off x="-49440" y="1613677"/>
            <a:ext cx="82465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−log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CE7B507-F287-A82B-4893-FB3130C5C3D5}"/>
              </a:ext>
            </a:extLst>
          </p:cNvPr>
          <p:cNvSpPr txBox="1"/>
          <p:nvPr/>
        </p:nvSpPr>
        <p:spPr>
          <a:xfrm>
            <a:off x="3633213" y="2713024"/>
            <a:ext cx="10711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hromosome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3A25B3B8-7A71-6453-75AE-3DED727A96C8}"/>
              </a:ext>
            </a:extLst>
          </p:cNvPr>
          <p:cNvSpPr txBox="1"/>
          <p:nvPr/>
        </p:nvSpPr>
        <p:spPr>
          <a:xfrm>
            <a:off x="200500" y="499999"/>
            <a:ext cx="455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A)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BC2E2D3F-88BB-C02F-114B-05E0FD3AE092}"/>
              </a:ext>
            </a:extLst>
          </p:cNvPr>
          <p:cNvSpPr txBox="1"/>
          <p:nvPr/>
        </p:nvSpPr>
        <p:spPr>
          <a:xfrm>
            <a:off x="264399" y="2972078"/>
            <a:ext cx="455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B)</a:t>
            </a:r>
          </a:p>
        </p:txBody>
      </p:sp>
      <p:pic>
        <p:nvPicPr>
          <p:cNvPr id="3" name="Graphic 2">
            <a:extLst>
              <a:ext uri="{FF2B5EF4-FFF2-40B4-BE49-F238E27FC236}">
                <a16:creationId xmlns:a16="http://schemas.microsoft.com/office/drawing/2014/main" id="{285AEA58-DCF1-7735-2247-5A871185904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674418" y="3327507"/>
            <a:ext cx="5495925" cy="3171825"/>
          </a:xfrm>
          <a:prstGeom prst="rect">
            <a:avLst/>
          </a:prstGeom>
        </p:spPr>
      </p:pic>
      <p:grpSp>
        <p:nvGrpSpPr>
          <p:cNvPr id="10" name="Group 9">
            <a:extLst>
              <a:ext uri="{FF2B5EF4-FFF2-40B4-BE49-F238E27FC236}">
                <a16:creationId xmlns:a16="http://schemas.microsoft.com/office/drawing/2014/main" id="{2B22A7A6-38AC-C2D4-7B3C-23AA72DC9D3D}"/>
              </a:ext>
            </a:extLst>
          </p:cNvPr>
          <p:cNvGrpSpPr/>
          <p:nvPr/>
        </p:nvGrpSpPr>
        <p:grpSpPr>
          <a:xfrm>
            <a:off x="5629109" y="5050580"/>
            <a:ext cx="298480" cy="1228931"/>
            <a:chOff x="7656029" y="4913420"/>
            <a:chExt cx="298480" cy="1228931"/>
          </a:xfrm>
        </p:grpSpPr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F3BB3ED2-F227-6B4D-414B-87C715071FDF}"/>
                </a:ext>
              </a:extLst>
            </p:cNvPr>
            <p:cNvSpPr txBox="1"/>
            <p:nvPr/>
          </p:nvSpPr>
          <p:spPr>
            <a:xfrm>
              <a:off x="7656029" y="4913420"/>
              <a:ext cx="2984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1200" baseline="30000" dirty="0"/>
                <a:t>2</a:t>
              </a:r>
            </a:p>
          </p:txBody>
        </p:sp>
        <p:pic>
          <p:nvPicPr>
            <p:cNvPr id="48" name="Graphic 47">
              <a:extLst>
                <a:ext uri="{FF2B5EF4-FFF2-40B4-BE49-F238E27FC236}">
                  <a16:creationId xmlns:a16="http://schemas.microsoft.com/office/drawing/2014/main" id="{61269FC6-E49D-9826-66E3-4FAE80410AF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7736978" y="5136511"/>
              <a:ext cx="193716" cy="100584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7887340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6BA3D41-A2D5-8F8B-E659-4E4F742FEB9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038DA82E-1A12-B14F-69C2-CBC295F172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6074" y="3373635"/>
            <a:ext cx="5527508" cy="306225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89CE70E-2F50-2370-7206-CB2631D5D80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3923" y="904279"/>
            <a:ext cx="5628002" cy="1865426"/>
          </a:xfrm>
          <a:prstGeom prst="rect">
            <a:avLst/>
          </a:prstGeom>
        </p:spPr>
      </p:pic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007412C0-DE6D-CDE3-11C4-4D36FC308DBD}"/>
              </a:ext>
            </a:extLst>
          </p:cNvPr>
          <p:cNvCxnSpPr>
            <a:cxnSpLocks/>
          </p:cNvCxnSpPr>
          <p:nvPr/>
        </p:nvCxnSpPr>
        <p:spPr>
          <a:xfrm>
            <a:off x="2714978" y="904279"/>
            <a:ext cx="0" cy="1629786"/>
          </a:xfrm>
          <a:prstGeom prst="line">
            <a:avLst/>
          </a:prstGeom>
          <a:ln w="12700">
            <a:prstDash val="sysDash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27B66ED7-7C97-F4BA-631E-29B0712DBF58}"/>
              </a:ext>
            </a:extLst>
          </p:cNvPr>
          <p:cNvCxnSpPr>
            <a:cxnSpLocks/>
          </p:cNvCxnSpPr>
          <p:nvPr/>
        </p:nvCxnSpPr>
        <p:spPr>
          <a:xfrm flipH="1">
            <a:off x="665599" y="2903397"/>
            <a:ext cx="2049379" cy="44060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58BFCDD8-30FF-808B-CEF9-9BDF58495909}"/>
              </a:ext>
            </a:extLst>
          </p:cNvPr>
          <p:cNvCxnSpPr>
            <a:cxnSpLocks/>
          </p:cNvCxnSpPr>
          <p:nvPr/>
        </p:nvCxnSpPr>
        <p:spPr>
          <a:xfrm>
            <a:off x="2724503" y="2903397"/>
            <a:ext cx="3459079" cy="43801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7BDCF78C-945E-44A4-2AEA-41E642CE76A9}"/>
              </a:ext>
            </a:extLst>
          </p:cNvPr>
          <p:cNvCxnSpPr>
            <a:cxnSpLocks/>
          </p:cNvCxnSpPr>
          <p:nvPr/>
        </p:nvCxnSpPr>
        <p:spPr>
          <a:xfrm>
            <a:off x="2714978" y="2534065"/>
            <a:ext cx="0" cy="353915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105EF541-CA09-2170-9B7C-06FF88C1534C}"/>
              </a:ext>
            </a:extLst>
          </p:cNvPr>
          <p:cNvSpPr txBox="1"/>
          <p:nvPr/>
        </p:nvSpPr>
        <p:spPr>
          <a:xfrm>
            <a:off x="665599" y="6872553"/>
            <a:ext cx="5545851" cy="12772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Manhattan plot and linkage disequilibrium (LD) plot for head smut disease susceptibility highlighting SNP locus S4_1010468.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Manhattan plot showing significant SNPs associated with head smut disease across the genome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reen</a:t>
            </a:r>
            <a:r>
              <a:rPr lang="en-US" sz="1100" b="0" i="0" dirty="0">
                <a:solidFill>
                  <a:srgbClr val="1C1D1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orizontal dashed </a:t>
            </a:r>
            <a:r>
              <a:rPr lang="en-US" sz="1100" b="0" i="0" dirty="0">
                <a:solidFill>
                  <a:srgbClr val="1C1D1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ine indicates the genome-wide significance threshold </a:t>
            </a:r>
            <a:r>
              <a:rPr lang="en-US" sz="11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100" i="1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1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value &lt;</a:t>
            </a:r>
            <a:r>
              <a:rPr lang="en-US" sz="1100" b="0" i="0" dirty="0">
                <a:solidFill>
                  <a:srgbClr val="1C1D1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E-5, 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−log</a:t>
            </a:r>
            <a:r>
              <a:rPr lang="en-US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5</a:t>
            </a:r>
            <a:r>
              <a:rPr lang="en-US" sz="1100" b="0" i="0" dirty="0">
                <a:solidFill>
                  <a:srgbClr val="1C1D1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. Black vertical dashed line shows the positions of quantitative trait nucleotide (QTN) at chromosome 4. (B) LD plot constructed using </a:t>
            </a:r>
            <a:r>
              <a:rPr lang="en-US" sz="1100" b="0" i="0" dirty="0" err="1">
                <a:solidFill>
                  <a:srgbClr val="1C1D1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aploview</a:t>
            </a:r>
            <a:r>
              <a:rPr lang="en-US" sz="1100" b="0" i="0" dirty="0">
                <a:solidFill>
                  <a:srgbClr val="1C1D1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4.2 for 100kb genomic region surrounding the significant SNPs. Color </a:t>
            </a:r>
            <a:r>
              <a:rPr lang="en-US" sz="11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cale indicates LD strength expressed as </a:t>
            </a:r>
            <a:r>
              <a:rPr lang="en-US" sz="1100" i="1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100" baseline="300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1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AECE25F-849B-00C3-2F20-2E0BA7BD7D8C}"/>
              </a:ext>
            </a:extLst>
          </p:cNvPr>
          <p:cNvSpPr txBox="1"/>
          <p:nvPr/>
        </p:nvSpPr>
        <p:spPr>
          <a:xfrm rot="16200000">
            <a:off x="-49440" y="1613677"/>
            <a:ext cx="82465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−log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DC616C6-85C1-FE9D-3AE3-7334245E777C}"/>
              </a:ext>
            </a:extLst>
          </p:cNvPr>
          <p:cNvSpPr txBox="1"/>
          <p:nvPr/>
        </p:nvSpPr>
        <p:spPr>
          <a:xfrm>
            <a:off x="3048788" y="2695079"/>
            <a:ext cx="10711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hromosome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3D2B7DB2-B0F1-39AE-22C5-8C4E12B2332E}"/>
              </a:ext>
            </a:extLst>
          </p:cNvPr>
          <p:cNvSpPr txBox="1"/>
          <p:nvPr/>
        </p:nvSpPr>
        <p:spPr>
          <a:xfrm>
            <a:off x="200500" y="499999"/>
            <a:ext cx="455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A)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E370D7B-5D47-EBED-5CBC-C839EA1ED996}"/>
              </a:ext>
            </a:extLst>
          </p:cNvPr>
          <p:cNvSpPr txBox="1"/>
          <p:nvPr/>
        </p:nvSpPr>
        <p:spPr>
          <a:xfrm>
            <a:off x="264399" y="2972078"/>
            <a:ext cx="455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B)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0B643EEC-D2AA-D453-E48B-186929164925}"/>
              </a:ext>
            </a:extLst>
          </p:cNvPr>
          <p:cNvGrpSpPr/>
          <p:nvPr/>
        </p:nvGrpSpPr>
        <p:grpSpPr>
          <a:xfrm>
            <a:off x="5697689" y="5071917"/>
            <a:ext cx="298480" cy="1228931"/>
            <a:chOff x="5530049" y="5020100"/>
            <a:chExt cx="298480" cy="1228931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29302C04-7D4B-D200-4246-4997F8E6517C}"/>
                </a:ext>
              </a:extLst>
            </p:cNvPr>
            <p:cNvSpPr txBox="1"/>
            <p:nvPr/>
          </p:nvSpPr>
          <p:spPr>
            <a:xfrm>
              <a:off x="5530049" y="5020100"/>
              <a:ext cx="2984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1200" baseline="30000" dirty="0"/>
                <a:t>2</a:t>
              </a:r>
            </a:p>
          </p:txBody>
        </p:sp>
        <p:pic>
          <p:nvPicPr>
            <p:cNvPr id="4" name="Graphic 3">
              <a:extLst>
                <a:ext uri="{FF2B5EF4-FFF2-40B4-BE49-F238E27FC236}">
                  <a16:creationId xmlns:a16="http://schemas.microsoft.com/office/drawing/2014/main" id="{31733423-8EAE-7EBE-D3A6-2EEB4BF1D44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5610998" y="5243191"/>
              <a:ext cx="193716" cy="100584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1186819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16F755C-17C3-1265-9FBA-FE10FA483DE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5FC6402-1CA5-E828-01AB-F165BD4C61E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3923" y="904279"/>
            <a:ext cx="5628002" cy="1865426"/>
          </a:xfrm>
          <a:prstGeom prst="rect">
            <a:avLst/>
          </a:prstGeom>
        </p:spPr>
      </p:pic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62125E90-C485-8C34-BEE5-FD7739FB38F2}"/>
              </a:ext>
            </a:extLst>
          </p:cNvPr>
          <p:cNvCxnSpPr>
            <a:cxnSpLocks/>
          </p:cNvCxnSpPr>
          <p:nvPr/>
        </p:nvCxnSpPr>
        <p:spPr>
          <a:xfrm>
            <a:off x="4696178" y="904279"/>
            <a:ext cx="0" cy="1629786"/>
          </a:xfrm>
          <a:prstGeom prst="line">
            <a:avLst/>
          </a:prstGeom>
          <a:ln w="12700">
            <a:prstDash val="sysDash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3494153D-9708-C51A-C47D-4045F62E0DAD}"/>
              </a:ext>
            </a:extLst>
          </p:cNvPr>
          <p:cNvCxnSpPr>
            <a:cxnSpLocks/>
          </p:cNvCxnSpPr>
          <p:nvPr/>
        </p:nvCxnSpPr>
        <p:spPr>
          <a:xfrm flipH="1">
            <a:off x="736437" y="2780550"/>
            <a:ext cx="3959741" cy="48649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92FE21AD-BE51-4CE2-AC0F-B8F2DC78AF8C}"/>
              </a:ext>
            </a:extLst>
          </p:cNvPr>
          <p:cNvCxnSpPr>
            <a:cxnSpLocks/>
          </p:cNvCxnSpPr>
          <p:nvPr/>
        </p:nvCxnSpPr>
        <p:spPr>
          <a:xfrm>
            <a:off x="4696178" y="2767764"/>
            <a:ext cx="1487404" cy="53229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5578F7E2-7744-F25A-5FF0-F224A385B288}"/>
              </a:ext>
            </a:extLst>
          </p:cNvPr>
          <p:cNvCxnSpPr/>
          <p:nvPr/>
        </p:nvCxnSpPr>
        <p:spPr>
          <a:xfrm>
            <a:off x="4696178" y="2534065"/>
            <a:ext cx="0" cy="233699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22108467-A208-785E-8669-4DE1ACA0402C}"/>
              </a:ext>
            </a:extLst>
          </p:cNvPr>
          <p:cNvSpPr txBox="1"/>
          <p:nvPr/>
        </p:nvSpPr>
        <p:spPr>
          <a:xfrm>
            <a:off x="718938" y="7021111"/>
            <a:ext cx="5545851" cy="12772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Manhattan plot and linkage disequilibrium (LD) plot for head smut disease susceptibility highlighting SNP locus S8_9590063.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Manhattan plot showing significant SNPs associated with head smut disease across the genome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reen</a:t>
            </a:r>
            <a:r>
              <a:rPr lang="en-US" sz="1100" b="0" i="0" dirty="0">
                <a:solidFill>
                  <a:srgbClr val="1C1D1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orizontal dashed </a:t>
            </a:r>
            <a:r>
              <a:rPr lang="en-US" sz="1100" b="0" i="0" dirty="0">
                <a:solidFill>
                  <a:srgbClr val="1C1D1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ine indicates the genome-wide significance threshold </a:t>
            </a:r>
            <a:r>
              <a:rPr lang="en-US" sz="11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100" i="1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1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value &lt;</a:t>
            </a:r>
            <a:r>
              <a:rPr lang="en-US" sz="1100" b="0" i="0" dirty="0">
                <a:solidFill>
                  <a:srgbClr val="1C1D1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E-5, 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−log</a:t>
            </a:r>
            <a:r>
              <a:rPr lang="en-US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5</a:t>
            </a:r>
            <a:r>
              <a:rPr lang="en-US" sz="1100" b="0" i="0" dirty="0">
                <a:solidFill>
                  <a:srgbClr val="1C1D1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. Black vertical dashed line shows the positions of quantitative trait nucleotide (QTN) at chromosome 8. (B) LD plot constructed using </a:t>
            </a:r>
            <a:r>
              <a:rPr lang="en-US" sz="1100" b="0" i="0" dirty="0" err="1">
                <a:solidFill>
                  <a:srgbClr val="1C1D1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aploview</a:t>
            </a:r>
            <a:r>
              <a:rPr lang="en-US" sz="1100" b="0" i="0" dirty="0">
                <a:solidFill>
                  <a:srgbClr val="1C1D1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4.2 for 100kb genomic region surrounding the significant SNPs. Color </a:t>
            </a:r>
            <a:r>
              <a:rPr lang="en-US" sz="11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cale indicates LD strength expressed as </a:t>
            </a:r>
            <a:r>
              <a:rPr lang="en-US" sz="1100" i="1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100" baseline="300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1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F8E8219-31D6-22DA-86C7-7AEC1C87BC29}"/>
              </a:ext>
            </a:extLst>
          </p:cNvPr>
          <p:cNvSpPr txBox="1"/>
          <p:nvPr/>
        </p:nvSpPr>
        <p:spPr>
          <a:xfrm rot="16200000">
            <a:off x="-49440" y="1613677"/>
            <a:ext cx="82465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−log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B6A4C9E5-CEBB-21E7-B2C4-057554420F05}"/>
              </a:ext>
            </a:extLst>
          </p:cNvPr>
          <p:cNvSpPr txBox="1"/>
          <p:nvPr/>
        </p:nvSpPr>
        <p:spPr>
          <a:xfrm>
            <a:off x="2638778" y="2695627"/>
            <a:ext cx="10711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hromosome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B94182EF-A7F7-DA1A-9411-8B17EEEECFEB}"/>
              </a:ext>
            </a:extLst>
          </p:cNvPr>
          <p:cNvSpPr txBox="1"/>
          <p:nvPr/>
        </p:nvSpPr>
        <p:spPr>
          <a:xfrm>
            <a:off x="200500" y="499999"/>
            <a:ext cx="455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A)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04274AE0-3677-4852-78E9-E938F7DC71E9}"/>
              </a:ext>
            </a:extLst>
          </p:cNvPr>
          <p:cNvSpPr txBox="1"/>
          <p:nvPr/>
        </p:nvSpPr>
        <p:spPr>
          <a:xfrm>
            <a:off x="264399" y="2972078"/>
            <a:ext cx="455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B)</a:t>
            </a:r>
          </a:p>
        </p:txBody>
      </p:sp>
      <p:pic>
        <p:nvPicPr>
          <p:cNvPr id="8" name="Graphic 7">
            <a:extLst>
              <a:ext uri="{FF2B5EF4-FFF2-40B4-BE49-F238E27FC236}">
                <a16:creationId xmlns:a16="http://schemas.microsoft.com/office/drawing/2014/main" id="{C99D2485-4165-1338-217C-2BFAD6F8D25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736942" y="3301996"/>
            <a:ext cx="5446640" cy="3534758"/>
          </a:xfrm>
          <a:prstGeom prst="rect">
            <a:avLst/>
          </a:prstGeom>
        </p:spPr>
      </p:pic>
      <p:grpSp>
        <p:nvGrpSpPr>
          <p:cNvPr id="6" name="Group 5">
            <a:extLst>
              <a:ext uri="{FF2B5EF4-FFF2-40B4-BE49-F238E27FC236}">
                <a16:creationId xmlns:a16="http://schemas.microsoft.com/office/drawing/2014/main" id="{3D3723C3-B2E9-56FC-932B-4BB5DD9F6E50}"/>
              </a:ext>
            </a:extLst>
          </p:cNvPr>
          <p:cNvGrpSpPr/>
          <p:nvPr/>
        </p:nvGrpSpPr>
        <p:grpSpPr>
          <a:xfrm>
            <a:off x="5674829" y="5414536"/>
            <a:ext cx="298480" cy="1228931"/>
            <a:chOff x="5530049" y="5020100"/>
            <a:chExt cx="298480" cy="1228931"/>
          </a:xfrm>
        </p:grpSpPr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FB362DEF-22AE-E148-AE8C-C7C7BD6DC27E}"/>
                </a:ext>
              </a:extLst>
            </p:cNvPr>
            <p:cNvSpPr txBox="1"/>
            <p:nvPr/>
          </p:nvSpPr>
          <p:spPr>
            <a:xfrm>
              <a:off x="5530049" y="5020100"/>
              <a:ext cx="2984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1200" baseline="30000" dirty="0"/>
                <a:t>2</a:t>
              </a:r>
            </a:p>
          </p:txBody>
        </p:sp>
        <p:pic>
          <p:nvPicPr>
            <p:cNvPr id="48" name="Graphic 47">
              <a:extLst>
                <a:ext uri="{FF2B5EF4-FFF2-40B4-BE49-F238E27FC236}">
                  <a16:creationId xmlns:a16="http://schemas.microsoft.com/office/drawing/2014/main" id="{B075A3D2-32DC-2AD1-1BF4-413F02FC6A0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5610998" y="5243191"/>
              <a:ext cx="193716" cy="100584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4238691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E957FAE-4472-5B29-6A45-2AE8B5F9479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Graphic 5">
            <a:extLst>
              <a:ext uri="{FF2B5EF4-FFF2-40B4-BE49-F238E27FC236}">
                <a16:creationId xmlns:a16="http://schemas.microsoft.com/office/drawing/2014/main" id="{3CA2E7CF-716A-127C-3BA7-D812AF4CC7E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655438" y="3342642"/>
            <a:ext cx="5528144" cy="349827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A974A52-3D64-675F-8B72-504C346A894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73923" y="904279"/>
            <a:ext cx="5628002" cy="1865426"/>
          </a:xfrm>
          <a:prstGeom prst="rect">
            <a:avLst/>
          </a:prstGeom>
        </p:spPr>
      </p:pic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2CE260CB-2FC6-477E-8ABC-465C8B6DFF25}"/>
              </a:ext>
            </a:extLst>
          </p:cNvPr>
          <p:cNvCxnSpPr>
            <a:cxnSpLocks/>
          </p:cNvCxnSpPr>
          <p:nvPr/>
        </p:nvCxnSpPr>
        <p:spPr>
          <a:xfrm>
            <a:off x="5467703" y="904279"/>
            <a:ext cx="0" cy="1629786"/>
          </a:xfrm>
          <a:prstGeom prst="line">
            <a:avLst/>
          </a:prstGeom>
          <a:ln w="12700">
            <a:prstDash val="sysDash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F57F6A17-DCCC-E2B9-1964-8A2A4C18B24E}"/>
              </a:ext>
            </a:extLst>
          </p:cNvPr>
          <p:cNvCxnSpPr>
            <a:cxnSpLocks/>
          </p:cNvCxnSpPr>
          <p:nvPr/>
        </p:nvCxnSpPr>
        <p:spPr>
          <a:xfrm flipH="1">
            <a:off x="665599" y="2767764"/>
            <a:ext cx="4802104" cy="57623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972D7F2F-3039-8654-7154-A1B4E1300BE7}"/>
              </a:ext>
            </a:extLst>
          </p:cNvPr>
          <p:cNvCxnSpPr>
            <a:cxnSpLocks/>
          </p:cNvCxnSpPr>
          <p:nvPr/>
        </p:nvCxnSpPr>
        <p:spPr>
          <a:xfrm>
            <a:off x="5467703" y="2767764"/>
            <a:ext cx="715879" cy="57364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E6D8CD8C-91B3-1198-6B59-CD22BD6249EC}"/>
              </a:ext>
            </a:extLst>
          </p:cNvPr>
          <p:cNvCxnSpPr/>
          <p:nvPr/>
        </p:nvCxnSpPr>
        <p:spPr>
          <a:xfrm>
            <a:off x="5468056" y="2534065"/>
            <a:ext cx="0" cy="233699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A181D16D-CF3F-7A38-64FE-EB25C19AD50D}"/>
              </a:ext>
            </a:extLst>
          </p:cNvPr>
          <p:cNvSpPr txBox="1"/>
          <p:nvPr/>
        </p:nvSpPr>
        <p:spPr>
          <a:xfrm>
            <a:off x="614998" y="6840921"/>
            <a:ext cx="5545851" cy="12772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Manhattan plot and linkage disequilibrium (LD) plot for head smut disease susceptibility highlighting SNP locus S9_53781289.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Manhattan plot showing significant SNPs associated with head smut disease across the genome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reen</a:t>
            </a:r>
            <a:r>
              <a:rPr lang="en-US" sz="1100" b="0" i="0" dirty="0">
                <a:solidFill>
                  <a:srgbClr val="1C1D1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orizontal dashed </a:t>
            </a:r>
            <a:r>
              <a:rPr lang="en-US" sz="1100" b="0" i="0" dirty="0">
                <a:solidFill>
                  <a:srgbClr val="1C1D1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ine indicates the genome-wide significance threshold </a:t>
            </a:r>
            <a:r>
              <a:rPr lang="en-US" sz="11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100" i="1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1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value &lt;</a:t>
            </a:r>
            <a:r>
              <a:rPr lang="en-US" sz="1100" b="0" i="0" dirty="0">
                <a:solidFill>
                  <a:srgbClr val="1C1D1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E-5, 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−log</a:t>
            </a:r>
            <a:r>
              <a:rPr lang="en-US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5</a:t>
            </a:r>
            <a:r>
              <a:rPr lang="en-US" sz="1100" b="0" i="0" dirty="0">
                <a:solidFill>
                  <a:srgbClr val="1C1D1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. Black vertical dashed line shows the positions of quantitative trait nucleotide (QTN) at chromosome 9. (B) LD plot constructed using </a:t>
            </a:r>
            <a:r>
              <a:rPr lang="en-US" sz="1100" b="0" i="0" dirty="0" err="1">
                <a:solidFill>
                  <a:srgbClr val="1C1D1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aploview</a:t>
            </a:r>
            <a:r>
              <a:rPr lang="en-US" sz="1100" b="0" i="0" dirty="0">
                <a:solidFill>
                  <a:srgbClr val="1C1D1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4.2 for 100kb genomic region surrounding the significant SNPs. Color </a:t>
            </a:r>
            <a:r>
              <a:rPr lang="en-US" sz="11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cale indicates LD strength expressed as </a:t>
            </a:r>
            <a:r>
              <a:rPr lang="en-US" sz="1100" i="1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100" baseline="300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100" dirty="0">
                <a:solidFill>
                  <a:srgbClr val="1C1D1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EC36A1A6-1EA7-7A44-2216-74D206D949D1}"/>
              </a:ext>
            </a:extLst>
          </p:cNvPr>
          <p:cNvSpPr txBox="1"/>
          <p:nvPr/>
        </p:nvSpPr>
        <p:spPr>
          <a:xfrm rot="16200000">
            <a:off x="-49440" y="1613677"/>
            <a:ext cx="82465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−log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03E44EC-6F20-B918-01A1-04A1D9608E19}"/>
              </a:ext>
            </a:extLst>
          </p:cNvPr>
          <p:cNvSpPr txBox="1"/>
          <p:nvPr/>
        </p:nvSpPr>
        <p:spPr>
          <a:xfrm>
            <a:off x="2638778" y="2695627"/>
            <a:ext cx="10711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hromosome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EA0C36A-7785-4C4D-C19B-0EF494F0C35C}"/>
              </a:ext>
            </a:extLst>
          </p:cNvPr>
          <p:cNvSpPr txBox="1"/>
          <p:nvPr/>
        </p:nvSpPr>
        <p:spPr>
          <a:xfrm>
            <a:off x="5530049" y="5020100"/>
            <a:ext cx="2984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200" baseline="30000" dirty="0"/>
              <a:t>2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BCBE9598-3BBB-4C5C-BAB3-87EFE52026CC}"/>
              </a:ext>
            </a:extLst>
          </p:cNvPr>
          <p:cNvSpPr txBox="1"/>
          <p:nvPr/>
        </p:nvSpPr>
        <p:spPr>
          <a:xfrm>
            <a:off x="200500" y="499999"/>
            <a:ext cx="455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A)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6374B0A-DBDF-E6D5-D902-A6924509427C}"/>
              </a:ext>
            </a:extLst>
          </p:cNvPr>
          <p:cNvSpPr txBox="1"/>
          <p:nvPr/>
        </p:nvSpPr>
        <p:spPr>
          <a:xfrm>
            <a:off x="264399" y="2972078"/>
            <a:ext cx="455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B)</a:t>
            </a:r>
          </a:p>
        </p:txBody>
      </p:sp>
      <p:pic>
        <p:nvPicPr>
          <p:cNvPr id="48" name="Graphic 47">
            <a:extLst>
              <a:ext uri="{FF2B5EF4-FFF2-40B4-BE49-F238E27FC236}">
                <a16:creationId xmlns:a16="http://schemas.microsoft.com/office/drawing/2014/main" id="{741AAC19-CC4C-ED4A-789D-C31B34AEA0B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610998" y="5243191"/>
            <a:ext cx="193716" cy="10058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57260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3</TotalTime>
  <Words>597</Words>
  <Application>Microsoft Office PowerPoint</Application>
  <PresentationFormat>Letter Paper (8.5x11 in)</PresentationFormat>
  <Paragraphs>30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nchung Park</dc:creator>
  <cp:lastModifiedBy>Ezekiel Ahn</cp:lastModifiedBy>
  <cp:revision>16</cp:revision>
  <dcterms:created xsi:type="dcterms:W3CDTF">2024-02-14T13:12:04Z</dcterms:created>
  <dcterms:modified xsi:type="dcterms:W3CDTF">2024-02-23T16:40:06Z</dcterms:modified>
</cp:coreProperties>
</file>